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  <p:sldId id="257" r:id="rId5"/>
    <p:sldId id="259" r:id="rId6"/>
    <p:sldId id="260" r:id="rId7"/>
    <p:sldId id="261" r:id="rId8"/>
    <p:sldId id="262" r:id="rId9"/>
    <p:sldId id="258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2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1.xml"/><Relationship Id="rId2" Type="http://schemas.openxmlformats.org/officeDocument/2006/relationships/tags" Target="../tags/tag64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5.xml"/><Relationship Id="rId1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6.xml"/><Relationship Id="rId1" Type="http://schemas.openxmlformats.org/officeDocument/2006/relationships/image" Target="../media/image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7.xml"/><Relationship Id="rId1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8.xml"/><Relationship Id="rId1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9.xml"/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70.xml"/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格 6"/>
          <p:cNvGraphicFramePr/>
          <p:nvPr>
            <p:custDataLst>
              <p:tags r:id="rId1"/>
            </p:custDataLst>
          </p:nvPr>
        </p:nvGraphicFramePr>
        <p:xfrm>
          <a:off x="291465" y="556260"/>
          <a:ext cx="5830570" cy="2872740"/>
        </p:xfrm>
        <a:graphic>
          <a:graphicData uri="http://schemas.openxmlformats.org/drawingml/2006/table">
            <a:tbl>
              <a:tblPr/>
              <a:tblGrid>
                <a:gridCol w="754380"/>
                <a:gridCol w="1296000"/>
                <a:gridCol w="648000"/>
                <a:gridCol w="1044000"/>
                <a:gridCol w="1044000"/>
                <a:gridCol w="1044000"/>
              </a:tblGrid>
              <a:tr h="324000"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Group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l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Semen HP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VCL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AP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SL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2400">
                <a:tc rowSpan="12"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 b="1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 h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Fresh group (0 mmol/L)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0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6.8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46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3.1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2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6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1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control group (0 mmol/L)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6.8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6.28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4.9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.0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8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0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1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3.0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0.53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9.4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10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0.3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4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2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9.2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97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9.3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42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1.2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1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4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2.7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5.47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0.4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7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9.6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80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8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16.9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9.2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2.68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8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0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8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6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0.3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8.63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6.7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.3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7.3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7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8.7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3.44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4.0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4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4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5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0.2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7.32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7.6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6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7.8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6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9.6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3.5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7.2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8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9.7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29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1.6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12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7.7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7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8.3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4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9.2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.22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8.0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3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7.68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6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0" name="表格 9"/>
          <p:cNvGraphicFramePr/>
          <p:nvPr/>
        </p:nvGraphicFramePr>
        <p:xfrm>
          <a:off x="291465" y="3556000"/>
          <a:ext cx="5830570" cy="2872800"/>
        </p:xfrm>
        <a:graphic>
          <a:graphicData uri="http://schemas.openxmlformats.org/drawingml/2006/table">
            <a:tbl>
              <a:tblPr/>
              <a:tblGrid>
                <a:gridCol w="754380"/>
                <a:gridCol w="1296000"/>
                <a:gridCol w="648000"/>
                <a:gridCol w="1044000"/>
                <a:gridCol w="1044000"/>
                <a:gridCol w="1044000"/>
              </a:tblGrid>
              <a:tr h="324000"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Group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l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Semen HP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VCL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AP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SL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2400">
                <a:tc rowSpan="12"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 b="1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8 h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Fresh group (0 mmol/L)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0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4.2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.4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1.0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9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4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3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control group (0 mmol/L)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2.2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1.5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0.0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3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3.6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1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1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3.6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2.0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4.1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8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4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0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2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7.3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5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3.0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2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4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2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4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5.6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3.3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3.9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5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7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4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8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9.6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.3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6.6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6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8.3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0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6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2.7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5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1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3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5.6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0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0.0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4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0.73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9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3.2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2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2.2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.4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4.18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8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3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6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3.0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3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6.6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4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9.1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3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0.1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1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2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3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4.7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1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8.5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.9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8.9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5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7.7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6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3" name="表格 12"/>
          <p:cNvGraphicFramePr/>
          <p:nvPr/>
        </p:nvGraphicFramePr>
        <p:xfrm>
          <a:off x="6249035" y="556260"/>
          <a:ext cx="5830570" cy="2872800"/>
        </p:xfrm>
        <a:graphic>
          <a:graphicData uri="http://schemas.openxmlformats.org/drawingml/2006/table">
            <a:tbl>
              <a:tblPr/>
              <a:tblGrid>
                <a:gridCol w="754380"/>
                <a:gridCol w="1296000"/>
                <a:gridCol w="648000"/>
                <a:gridCol w="1044000"/>
                <a:gridCol w="1044000"/>
                <a:gridCol w="1044000"/>
              </a:tblGrid>
              <a:tr h="324000"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Group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l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Semen HP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VCL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AP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SL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2400">
                <a:tc rowSpan="12"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 b="1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6 h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Fresh group (0 mmol/L)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0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2.0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.2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9.4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5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9.9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4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control group (0 mmol/L)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5.3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8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8.4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0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1.88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6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1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4.43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4.2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8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5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1.7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4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2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4.7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4.5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8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2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1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7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4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0.1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.5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93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0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5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5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8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6.08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7.9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3.7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5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1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4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6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0.5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8.0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0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6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5.4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1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4.5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.7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0.7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6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3.2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0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9.5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0.1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4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3.0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8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3.6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.6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1.0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4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5.0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3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5.4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3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1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2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4.3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5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0.6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6.6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3.5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8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3.6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2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6" name="表格 15"/>
          <p:cNvGraphicFramePr/>
          <p:nvPr/>
        </p:nvGraphicFramePr>
        <p:xfrm>
          <a:off x="6249035" y="3556000"/>
          <a:ext cx="5830570" cy="2872740"/>
        </p:xfrm>
        <a:graphic>
          <a:graphicData uri="http://schemas.openxmlformats.org/drawingml/2006/table">
            <a:tbl>
              <a:tblPr/>
              <a:tblGrid>
                <a:gridCol w="754380"/>
                <a:gridCol w="1296000"/>
                <a:gridCol w="648000"/>
                <a:gridCol w="1044000"/>
                <a:gridCol w="1044000"/>
                <a:gridCol w="1044000"/>
              </a:tblGrid>
              <a:tr h="324000"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Group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l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Semen HP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VCL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AP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SL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,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μm/s</a:t>
                      </a:r>
                      <a:endParaRPr 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2400">
                <a:tc rowSpan="12"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 b="1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44 h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Fresh group (0 mmol/L)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0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6.8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5.4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9.7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7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0.08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0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control group (0 mmol/L)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5.9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.7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5.2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6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0.0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4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1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7.4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.7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4.7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3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9.8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9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2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4.3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5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3.8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5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7.9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1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4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5.8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8.8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8.6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0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1.83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7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8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3.83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7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4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5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38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4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6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   TMAO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7.41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92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8.3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5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2.1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2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6.9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56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3.2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9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9.1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18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6.80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1.2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.95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7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0.1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41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8.9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3.50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7.67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9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1.86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1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3.0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.75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0.69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6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2.93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47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400">
                <a:tc vMerge="1"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just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0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mmol/L</a:t>
                      </a:r>
                      <a:r>
                        <a:rPr lang="en-US" altLang="en-US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 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  <a:sym typeface="+mn-ea"/>
                        </a:rPr>
                        <a:t>  BET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105 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kPa</a:t>
                      </a:r>
                      <a:endParaRPr lang="en-US" altLang="zh-CN" sz="9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4.1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.34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3.52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.13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**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0" indent="0" algn="ctr" fontAlgn="ctr">
                        <a:lnSpc>
                          <a:spcPct val="12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1.84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宋体" panose="02010600030101010101" pitchFamily="2" charset="-122"/>
                        </a:rPr>
                        <a:t>±</a:t>
                      </a:r>
                      <a:r>
                        <a:rPr lang="en-US" altLang="zh-CN" sz="9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.39</a:t>
                      </a:r>
                      <a:r>
                        <a:rPr lang="en-US" altLang="zh-CN" sz="900" baseline="30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##</a:t>
                      </a:r>
                      <a:endParaRPr lang="en-US" altLang="zh-CN" sz="900" baseline="3000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8580" marR="68580" marT="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8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9" name="文本框 18"/>
          <p:cNvSpPr txBox="1"/>
          <p:nvPr/>
        </p:nvSpPr>
        <p:spPr>
          <a:xfrm>
            <a:off x="272415" y="178435"/>
            <a:ext cx="11787505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 S1. Effects of different concentrations of TMAO or BET on kinematic parameters of boar sperm under HP stress.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0" y="6407785"/>
            <a:ext cx="11379200" cy="450215"/>
          </a:xfrm>
          <a:prstGeom prst="rect">
            <a:avLst/>
          </a:prstGeom>
        </p:spPr>
        <p:txBody>
          <a:bodyPr wrap="square">
            <a:spAutoFit/>
          </a:bodyPr>
          <a:p>
            <a:pPr marL="1656080" indent="228600" algn="just" defTabSz="266700">
              <a:lnSpc>
                <a:spcPts val="1400"/>
              </a:lnSpc>
            </a:pP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 are presented as mean ± SD (n = 3). Symbols indicate statistical significance: # compared with the fresh control group, * compared with the HP control group,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 &lt; 0.05; no symbol indicates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 &gt; 0.05.</a:t>
            </a:r>
            <a:endParaRPr lang="en-US" altLang="zh-CN" sz="1400" dirty="0" err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" name="文本框 9"/>
          <p:cNvSpPr txBox="1"/>
          <p:nvPr/>
        </p:nvSpPr>
        <p:spPr>
          <a:xfrm>
            <a:off x="488315" y="228600"/>
            <a:ext cx="6813550" cy="8115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1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epresentative images of boar sperm plasma membrane integrity, acrosome integrity, and viability.</a:t>
            </a:r>
            <a:r>
              <a:rPr lang="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 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88315" y="4611370"/>
            <a:ext cx="598233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 Plasma membrane integrity: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 spermatozoa with intact plasma membrane (arrow),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 spermatozoa with damaged plasma membrane (arrow).</a:t>
            </a:r>
            <a:r>
              <a:rPr lang="en-US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 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16" name="图片 15" descr="中文核心，质膜顶体活率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88745" y="1040130"/>
            <a:ext cx="9048435" cy="32400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488315" y="5673090"/>
            <a:ext cx="857059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 Acrosome integrity: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 spermatozoa with intact acrosome (arrow),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 spermatozoa with damaged acrosome (arrow).</a:t>
            </a:r>
            <a:r>
              <a:rPr lang="en-US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 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6536690" y="4611370"/>
            <a:ext cx="609600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C) Sperm viability: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 live spermatozoa (arrow),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 dead spermatozoa (arrow).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" name="文本框 9"/>
          <p:cNvSpPr txBox="1"/>
          <p:nvPr/>
        </p:nvSpPr>
        <p:spPr>
          <a:xfrm>
            <a:off x="488315" y="228600"/>
            <a:ext cx="7888605" cy="8115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2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epresentative images of boar sperm mitochondrial membrane potential (MMP) staining.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792730" y="4923155"/>
            <a:ext cx="609600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 Low MMP, green fluorescence.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 High MMP, red fluorescence.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C) Merged fluorescence image.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2" name="图片 1" descr="MMP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62940" y="1284605"/>
            <a:ext cx="10922635" cy="305054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" name="文本框 9"/>
          <p:cNvSpPr txBox="1"/>
          <p:nvPr/>
        </p:nvSpPr>
        <p:spPr>
          <a:xfrm>
            <a:off x="488315" y="228600"/>
            <a:ext cx="7888605" cy="8115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3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epresentative images of boar sperm DNA fragmentation index (DFI) staining.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792730" y="5612765"/>
            <a:ext cx="609600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 Intact double-stranded DNA, green fluorescence.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 Damaged single-stranded DNA, red fluorescence.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3" name="图片 2" descr="DFI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05790" y="1040130"/>
            <a:ext cx="10980420" cy="408432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" name="文本框 9"/>
          <p:cNvSpPr txBox="1"/>
          <p:nvPr/>
        </p:nvSpPr>
        <p:spPr>
          <a:xfrm>
            <a:off x="488315" y="559435"/>
            <a:ext cx="7888605" cy="8115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4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epresentative fluorescence staining images of ROS in boar sperm.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498090" y="4214495"/>
            <a:ext cx="69932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perm stained with the DCFH-DA probe emitted green fluorescence.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2" name="图片 1" descr="RO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96900" y="1637030"/>
            <a:ext cx="11168038" cy="19800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80645" y="514985"/>
            <a:ext cx="9023350" cy="57467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5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PLS-DA score plot (left) and permutation test plot (right) of boar sperm stored at room temperature under HP stress.</a:t>
            </a:r>
            <a:r>
              <a:rPr lang="zh-CN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（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 vs. C, B vs. C,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H vs. C</a:t>
            </a:r>
            <a:r>
              <a:rPr lang="zh-CN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）</a:t>
            </a:r>
            <a:endParaRPr lang="zh-CN" altLang="en-US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2" name="图片 1" descr="image_174170224359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1089660"/>
            <a:ext cx="6389078" cy="2340000"/>
          </a:xfrm>
          <a:prstGeom prst="rect">
            <a:avLst/>
          </a:prstGeom>
        </p:spPr>
      </p:pic>
      <p:pic>
        <p:nvPicPr>
          <p:cNvPr id="3" name="图片 2" descr="image_17416910509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1450" y="3740785"/>
            <a:ext cx="6392715" cy="2340000"/>
          </a:xfrm>
          <a:prstGeom prst="rect">
            <a:avLst/>
          </a:prstGeom>
        </p:spPr>
      </p:pic>
      <p:pic>
        <p:nvPicPr>
          <p:cNvPr id="8" name="图片 7" descr="image_174170209600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99455" y="1089660"/>
            <a:ext cx="6392715" cy="23400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2651125" y="5940425"/>
            <a:ext cx="751205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: pressurized control group; T: 105 kPa + TMAO group;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: 105 kPa + BET group; H: 105 kPa + TMAO + BET group. 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4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 descr="KEGG富集分析气泡图（P_value )_MetabsetEnrich_Origin_C8_vs_C0 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96240" y="3366770"/>
            <a:ext cx="4858920" cy="3240000"/>
          </a:xfrm>
          <a:prstGeom prst="rect">
            <a:avLst/>
          </a:prstGeom>
        </p:spPr>
      </p:pic>
      <p:pic>
        <p:nvPicPr>
          <p:cNvPr id="6" name="图片 5" descr="KEGG富集分析气泡图（P_value )_MetabsetEnrich_Origin_C20_vs_C0 (1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41745" y="3366770"/>
            <a:ext cx="4858920" cy="3240000"/>
          </a:xfrm>
          <a:prstGeom prst="rect">
            <a:avLst/>
          </a:prstGeom>
        </p:spPr>
      </p:pic>
      <p:pic>
        <p:nvPicPr>
          <p:cNvPr id="4" name="图片 3" descr="KEGG富集分析气泡图（P_value )_MetabsetEnrich_Origin_H_vs_C0 (1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1745" y="127000"/>
            <a:ext cx="4858920" cy="324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714375" y="864235"/>
            <a:ext cx="6096000" cy="96329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6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KEGG pathway enrichment analysis bubble plot of boar sperm stored at room temperature under HP stress</a:t>
            </a:r>
            <a:endParaRPr lang="en-US" altLang="zh-CN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zh-CN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（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 vs. C</a:t>
            </a:r>
            <a:r>
              <a:rPr lang="zh-CN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、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 vs. C</a:t>
            </a:r>
            <a:r>
              <a:rPr lang="zh-CN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、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H vs. C</a:t>
            </a:r>
            <a:r>
              <a:rPr lang="zh-CN" altLang="en-US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）</a:t>
            </a:r>
            <a:endParaRPr lang="zh-CN" altLang="en-US" b="1" dirty="0" err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45745" y="2472690"/>
            <a:ext cx="609600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None/>
            </a:pP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: pressurized control group; T: 105 kPa+TMAO group; </a:t>
            </a:r>
            <a:endParaRPr lang="en-US" altLang="ko-KR" b="1" dirty="0" err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>
              <a:buClrTx/>
              <a:buSzTx/>
              <a:buNone/>
            </a:pP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: 105 kPa+BET group; H: 105 kPa+TMAO+BET group.</a:t>
            </a:r>
            <a:endParaRPr lang="en-US" altLang="ko-KR" b="1" dirty="0" err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TABLE_ENDDRAG_ORIGIN_RECT" val="632*391"/>
  <p:tag name="TABLE_ENDDRAG_RECT" val="70*42*632*391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00</Words>
  <Application>WPS 演示</Application>
  <PresentationFormat>宽屏</PresentationFormat>
  <Paragraphs>661</Paragraphs>
  <Slides>7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2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Times New Roman</vt:lpstr>
      <vt:lpstr>Arial</vt:lpstr>
      <vt:lpstr>Palatino Linotype</vt:lpstr>
      <vt:lpstr>等线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秦程</cp:lastModifiedBy>
  <cp:revision>159</cp:revision>
  <dcterms:created xsi:type="dcterms:W3CDTF">2019-06-19T02:08:00Z</dcterms:created>
  <dcterms:modified xsi:type="dcterms:W3CDTF">2025-09-26T03:44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2175</vt:lpwstr>
  </property>
  <property fmtid="{D5CDD505-2E9C-101B-9397-08002B2CF9AE}" pid="3" name="ICV">
    <vt:lpwstr>899A5C5B80134CB388EF90B988B6377E_11</vt:lpwstr>
  </property>
</Properties>
</file>